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2916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97CCF-10A3-41DD-ACF5-1033730FA52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21B709-C26A-46BE-90CA-BDCF79160F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A0454B-4138-43A8-AE3D-CB3D4626A8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62415B-6BDF-4648-89B2-BE08EE7FC4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1C495B-9CC5-4D8F-A60F-59194BAB08E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42E683-49C6-4414-8A3A-7CA059C8F3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D1F6D5-55A1-4E3D-A665-74D9921F9E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5AEA5-E5F3-49AA-AEB0-258130FC83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C8EABD-98F4-4829-B6D2-EAA9649F7C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BE0E2-EF3E-456A-BCDC-119DF05F81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38DC9D-7B57-4ED3-A93F-6DDCBCCF2A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13BD6-EB2D-47E0-847E-BF65DBFA2B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C7B685-1A71-435A-AA14-260F03D4D16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554040" y="685800"/>
          <a:ext cx="5738760" cy="6842160"/>
        </p:xfrm>
        <a:graphic>
          <a:graphicData uri="http://schemas.openxmlformats.org/drawingml/2006/table">
            <a:tbl>
              <a:tblPr/>
              <a:tblGrid>
                <a:gridCol w="969840"/>
                <a:gridCol w="1295640"/>
                <a:gridCol w="838080"/>
                <a:gridCol w="1752480"/>
                <a:gridCol w="882720"/>
              </a:tblGrid>
              <a:tr h="783720"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PCR TYP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PECIES /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RECEPTO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PRIMER SEQUENC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PRODUCT LENGTH–BASE PAIRS (bp-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8400">
                <a:tc rowSpan="8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Real time PC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hVD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ggaagcctttgggtctgaag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9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8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nti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gccattgcctccatccctga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8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h</a:t>
                      </a:r>
                      <a:r>
                        <a:rPr b="0" lang="el-GR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β2-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microglobul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atgcggcatcttcaaacc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7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74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nti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tgactttgtcacagcccaagat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8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mVD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gcattgtctccccagacc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8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8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nti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cagtgtgttggataggcgg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74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m</a:t>
                      </a:r>
                      <a:r>
                        <a:rPr b="0" lang="el-GR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β2-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microglobul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catacgcctgcagagttaagc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7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74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nti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gatcacatgtctcgatcccagtag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8400">
                <a:tc rowSpan="6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Conventional PC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hVDR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gcccaccataagacctac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2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8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nti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gattggagaagctggacg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8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hVDR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ctgccttcttcggggaac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34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80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nti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ccttctctgttgacctcgc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38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mVD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ggacttccggcctccaat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17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74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nti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gggtcatcggagccttct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389160"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emi-nested PC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mVD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ttctccaaggcccacact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rowSpan="2"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13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86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antisen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Candara"/>
                          <a:ea typeface="Times New Roman"/>
                        </a:rPr>
                        <a:t>cagtgtgttggataggcgg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1440" marR="9144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</a:tbl>
          </a:graphicData>
        </a:graphic>
      </p:graphicFrame>
      <p:sp>
        <p:nvSpPr>
          <p:cNvPr id="42" name="TextBox 22"/>
          <p:cNvSpPr/>
          <p:nvPr/>
        </p:nvSpPr>
        <p:spPr>
          <a:xfrm>
            <a:off x="1981080" y="7924680"/>
            <a:ext cx="42451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8T21:32:08Z</dcterms:created>
  <dc:creator>Ismail,Ahmed Abdelbaset Ahmed Attia</dc:creator>
  <dc:description/>
  <dc:language>en-US</dc:language>
  <cp:lastModifiedBy>Mariusz Ratajczak</cp:lastModifiedBy>
  <cp:lastPrinted>2016-02-11T23:45:22Z</cp:lastPrinted>
  <dcterms:modified xsi:type="dcterms:W3CDTF">2016-02-26T14:03:44Z</dcterms:modified>
  <cp:revision>88</cp:revision>
  <dc:subject/>
  <dc:title>PowerPoint Presentation</dc:title>
</cp:coreProperties>
</file>